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102" d="100"/>
          <a:sy n="102" d="100"/>
        </p:scale>
        <p:origin x="-1408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054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753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2054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44929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5494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5084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1582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2892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4249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8522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 smtClean="0"/>
              <a:t>プレースホルダーまでドラッグするかアイコンをクリックして図を追加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1560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8F58B-87E0-0744-BEF4-6372ED03FDB3}" type="datetimeFigureOut">
              <a:rPr kumimoji="1" lang="ja-JP" altLang="en-US" smtClean="0"/>
              <a:t>15/09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B99D8A-CCEF-0046-B7DE-8B0E66C3003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4439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Fig1b 32_120517mpk6kr.png"/>
          <p:cNvPicPr>
            <a:picLocks noChangeAspect="1"/>
          </p:cNvPicPr>
          <p:nvPr/>
        </p:nvPicPr>
        <p:blipFill>
          <a:blip r:embed="rId2"/>
          <a:srcRect l="47072" t="11451" r="31282" b="64073"/>
          <a:stretch>
            <a:fillRect/>
          </a:stretch>
        </p:blipFill>
        <p:spPr>
          <a:xfrm>
            <a:off x="2740755" y="3961696"/>
            <a:ext cx="1331383" cy="860777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2297125" y="4057841"/>
            <a:ext cx="40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baseline="30000" dirty="0" smtClean="0">
                <a:latin typeface="Helvetica"/>
                <a:cs typeface="Helvetica"/>
              </a:rPr>
              <a:t>32</a:t>
            </a:r>
            <a:r>
              <a:rPr kumimoji="1" lang="en-US" altLang="ja-JP" sz="1200" b="1" dirty="0" smtClean="0">
                <a:latin typeface="Helvetica"/>
                <a:cs typeface="Helvetica"/>
              </a:rPr>
              <a:t>P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181734" y="4431806"/>
            <a:ext cx="518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CBB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694371" y="3684697"/>
            <a:ext cx="10054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MBP-MPK6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 rot="16200000">
            <a:off x="2760343" y="3655314"/>
            <a:ext cx="4283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WT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 rot="16200000">
            <a:off x="3038206" y="3541877"/>
            <a:ext cx="6551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Y227D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 rot="16200000">
            <a:off x="3459225" y="3546197"/>
            <a:ext cx="6465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Helvetica"/>
                <a:cs typeface="Helvetica"/>
              </a:rPr>
              <a:t>T225A</a:t>
            </a:r>
            <a:endParaRPr kumimoji="1"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846184" y="5086740"/>
            <a:ext cx="3595637" cy="122341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/>
                <a:cs typeface="Times New Roman"/>
              </a:rPr>
              <a:t>S4 Fig. GST-MKK10-2D </a:t>
            </a:r>
            <a:r>
              <a:rPr lang="en-US" altLang="ja-JP" sz="1050" dirty="0" err="1">
                <a:latin typeface="Times New Roman"/>
                <a:cs typeface="Times New Roman"/>
              </a:rPr>
              <a:t>phosphoylates</a:t>
            </a:r>
            <a:r>
              <a:rPr lang="en-US" altLang="ja-JP" sz="1050" dirty="0">
                <a:latin typeface="Times New Roman"/>
                <a:cs typeface="Times New Roman"/>
              </a:rPr>
              <a:t> WT and mutant MBP-MPK6 protein </a:t>
            </a:r>
            <a:r>
              <a:rPr lang="en-US" altLang="ja-JP" sz="1050" i="1" dirty="0">
                <a:latin typeface="Times New Roman"/>
                <a:cs typeface="Times New Roman"/>
              </a:rPr>
              <a:t>in vitro</a:t>
            </a:r>
            <a:r>
              <a:rPr lang="en-US" altLang="ja-JP" sz="1050" dirty="0">
                <a:latin typeface="Times New Roman"/>
                <a:cs typeface="Times New Roman"/>
              </a:rPr>
              <a:t>.</a:t>
            </a:r>
            <a:endParaRPr lang="ja-JP" altLang="ja-JP" sz="1050" dirty="0">
              <a:latin typeface="Times New Roman"/>
              <a:cs typeface="Times New Roman"/>
            </a:endParaRPr>
          </a:p>
          <a:p>
            <a:r>
              <a:rPr lang="en-US" altLang="ja-JP" sz="1050" dirty="0">
                <a:latin typeface="Times New Roman"/>
                <a:cs typeface="Times New Roman"/>
              </a:rPr>
              <a:t>Phosphorylation of WT and mutant forms (Y227D and T225A) of MBP-MPK6 proteins were assayed using [γ-</a:t>
            </a:r>
            <a:r>
              <a:rPr lang="en-US" altLang="ja-JP" sz="1050" baseline="30000" dirty="0">
                <a:latin typeface="Times New Roman"/>
                <a:cs typeface="Times New Roman"/>
              </a:rPr>
              <a:t>32</a:t>
            </a:r>
            <a:r>
              <a:rPr lang="en-US" altLang="ja-JP" sz="1050" dirty="0">
                <a:latin typeface="Times New Roman"/>
                <a:cs typeface="Times New Roman"/>
              </a:rPr>
              <a:t>P]ATP as a substrate as described in Materials and Methods, CBB, loading control.</a:t>
            </a:r>
            <a:endParaRPr lang="ja-JP" altLang="ja-JP" sz="1050" dirty="0">
              <a:latin typeface="Times New Roman"/>
              <a:cs typeface="Times New Roman"/>
            </a:endParaRPr>
          </a:p>
          <a:p>
            <a:endParaRPr kumimoji="1" lang="ja-JP" altLang="en-US" sz="1050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22926919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既定の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既定のテーマ.thmx</Template>
  <TotalTime>0</TotalTime>
  <Words>67</Words>
  <Application>Microsoft Macintosh PowerPoint</Application>
  <PresentationFormat>画面に合わせる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既定のテーマ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高辻 博志</dc:creator>
  <cp:lastModifiedBy>高辻 博志</cp:lastModifiedBy>
  <cp:revision>1</cp:revision>
  <dcterms:created xsi:type="dcterms:W3CDTF">2015-09-28T01:12:33Z</dcterms:created>
  <dcterms:modified xsi:type="dcterms:W3CDTF">2015-09-28T01:13:00Z</dcterms:modified>
</cp:coreProperties>
</file>